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248C3E4-9239-D604-9635-C5EA8AF55C0D}" name="James Burns" initials="JB" userId="S::je.burns@mail.utoronto.ca::e28dd781-7100-42e5-b0c1-7d4c6953c02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53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0" d="100"/>
        <a:sy n="13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1527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0899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6745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8317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0552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511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64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7795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6944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7178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6824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7869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">
            <a:extLst>
              <a:ext uri="{FF2B5EF4-FFF2-40B4-BE49-F238E27FC236}">
                <a16:creationId xmlns:a16="http://schemas.microsoft.com/office/drawing/2014/main" id="{833217B8-2960-6106-1C51-4699EA4F4C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3607" y="265375"/>
            <a:ext cx="4050000" cy="3240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D405338-A80F-5ACD-6B6F-571E04DCC6F4}"/>
              </a:ext>
            </a:extLst>
          </p:cNvPr>
          <p:cNvSpPr txBox="1"/>
          <p:nvPr/>
        </p:nvSpPr>
        <p:spPr>
          <a:xfrm>
            <a:off x="287958" y="119080"/>
            <a:ext cx="4141167" cy="3231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DC 8: Figure 5S(a-c): Total hip bone mineral density</a:t>
            </a:r>
          </a:p>
          <a:p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Intermediate values vs. baseline*</a:t>
            </a: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ngitudinal changes TAF vs. TDF</a:t>
            </a: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Percentage changes TAF vs. TDF</a:t>
            </a:r>
          </a:p>
          <a:p>
            <a:pPr marL="342900" indent="-342900" algn="just">
              <a:buAutoNum type="alphaLcParenR"/>
            </a:pP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*TAF: red, TDF: blue</a:t>
            </a:r>
          </a:p>
          <a:p>
            <a:pPr algn="just"/>
            <a:r>
              <a:rPr lang="en-GB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ime relates to the date of the first measurement of the parameter in question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MD: bone mineral density, TAF: tenofovir alafenamide fumarate, TDF: tenofovir disoproxil fumarate.</a:t>
            </a:r>
          </a:p>
          <a:p>
            <a:pPr marL="342900" indent="-342900">
              <a:buAutoNum type="alphaLcParenR"/>
            </a:pP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54FB4C1-6886-C5B6-2F56-7D3DD24878D0}"/>
              </a:ext>
            </a:extLst>
          </p:cNvPr>
          <p:cNvSpPr txBox="1"/>
          <p:nvPr/>
        </p:nvSpPr>
        <p:spPr>
          <a:xfrm>
            <a:off x="4371975" y="1143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9753C4D-4ECA-84CF-1704-64134EED93C3}"/>
              </a:ext>
            </a:extLst>
          </p:cNvPr>
          <p:cNvSpPr txBox="1"/>
          <p:nvPr/>
        </p:nvSpPr>
        <p:spPr>
          <a:xfrm>
            <a:off x="295275" y="3228975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63E658-B0AE-5C26-ACC0-06644E1390BE}"/>
              </a:ext>
            </a:extLst>
          </p:cNvPr>
          <p:cNvSpPr txBox="1"/>
          <p:nvPr/>
        </p:nvSpPr>
        <p:spPr>
          <a:xfrm>
            <a:off x="4419600" y="3200400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pic>
        <p:nvPicPr>
          <p:cNvPr id="14" name="Picture 13" descr="Chart, scatter chart&#10;&#10;Description automatically generated">
            <a:extLst>
              <a:ext uri="{FF2B5EF4-FFF2-40B4-BE49-F238E27FC236}">
                <a16:creationId xmlns:a16="http://schemas.microsoft.com/office/drawing/2014/main" id="{8E9804CE-00D6-2C1E-EB6F-81410F58518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190" y="3656450"/>
            <a:ext cx="4051935" cy="2948940"/>
          </a:xfrm>
          <a:prstGeom prst="rect">
            <a:avLst/>
          </a:prstGeom>
        </p:spPr>
      </p:pic>
      <p:pic>
        <p:nvPicPr>
          <p:cNvPr id="16" name="Picture 15" descr="Chart&#10;&#10;Description automatically generated">
            <a:extLst>
              <a:ext uri="{FF2B5EF4-FFF2-40B4-BE49-F238E27FC236}">
                <a16:creationId xmlns:a16="http://schemas.microsoft.com/office/drawing/2014/main" id="{4B0A71FF-5BBC-B3C7-8708-8265D049427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3607" y="3656450"/>
            <a:ext cx="4051935" cy="29489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57471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0</TotalTime>
  <Words>79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nsort diagram?</dc:title>
  <dc:creator>David Dunn</dc:creator>
  <cp:lastModifiedBy>Arun Sharma</cp:lastModifiedBy>
  <cp:revision>26</cp:revision>
  <dcterms:created xsi:type="dcterms:W3CDTF">2022-04-11T09:37:24Z</dcterms:created>
  <dcterms:modified xsi:type="dcterms:W3CDTF">2024-02-29T09:20:29Z</dcterms:modified>
</cp:coreProperties>
</file>